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70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15CB3-0DE5-EB1C-0D95-44F07895CC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C87F316-06B4-CCE8-821D-6E20DAB5967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D5698B-1394-20CD-D6A3-F2DA3974B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3BA5BC-3C1D-7CCC-253F-B25FE40E58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4EBFD5-97D3-66D0-F3D6-CE7EC9AB7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849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D4A95-F9C3-2D96-8320-7493FDEF3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73EF1C-0386-F52F-DDB0-D2B8A3383C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83A1CB-F9C7-0533-03BD-C4ED4E356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C625B9-1C7E-AA32-47F8-B703B6B1D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D32007-C7A2-1835-8B27-F41D4951D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7562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EFBA88-1494-429B-0142-0220F2D57C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233FAD-F07F-2561-D677-4456CDC56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1FA66-81D4-E197-31C1-DC4DF02CE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208AF8-B43C-1823-1387-7F4D0C6CA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54325E-E4B1-F802-D7C5-91E2708EE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516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1C77A0-1466-F957-5909-AF86F1709F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71FB3D-9DFA-1B31-7F2A-3702760F74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F3F504-36C4-1F7A-5117-A36D8D5A8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9FAF77-174E-21DB-900B-5728047F6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1F8D8A-ED31-9DC1-3BF4-18E9051AB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016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6FD118-5D74-F9C8-0A2B-FC48F671A9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AE8F294-72C6-D900-AB29-ED474AD26E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0641A3-52E3-01BA-8229-A644FC171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FBCEE7-247F-EFEA-93E0-D3C9A97D1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B42AEE-D56C-F3E2-20DB-D3E5DDFE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22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B96D2-0D08-B5BA-514E-F7E9046253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771DC6-D7E4-5BBD-F06B-4FC196287A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E53DC2-45EE-B8FF-37C6-A5880AD6CE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D8D974-1E42-C9A7-A39A-C6917A6B9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964B19-033B-5547-EC39-20BBC4AAD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037A93-99D3-E2B6-7F8D-7E70AAD76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4428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991179-258F-8A7F-24E4-65E65DA54A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508396-88BF-437D-3E50-5D0F26BF86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2DE4C5-C695-6EA5-A84E-7525829AEF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0499403-8BC3-6B15-2133-D03904B92D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0E59129-E1D4-BCCE-4039-E6D4B703CB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165BCA-5FD3-0CAB-3F2B-48938EB73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17F615-4E37-DCAE-CDA4-0C8C2F0BC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0BD82F-0FD1-ABF5-952B-FA43F3059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494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2E89E-390F-0F7A-DDF0-A0B82D1C70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5ED8AE-0708-6530-6AAA-D04451B91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D0F6B9-4968-F4E9-DBCF-ECA850ED9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5A784E-0B6D-E1E8-0E52-F63DAAF2B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1970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954C25-5E4D-796C-C5BA-3816B5E51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7D56FC-63EB-1E8E-EAAC-6ACC4C4F6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B5CAFE7-B6F9-C6E6-759F-666203474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81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4D7C93-6637-163B-ED85-76468343A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9A1010-EDF3-9D6F-DA7A-0EE878FD1A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F1E3DD-7F69-AEED-2616-6757C2AA98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3727A2-DC95-60BB-FC17-7C17272E1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3E13CD-B869-07EC-CDF1-3BFED69F8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A67D02-5F62-8C7C-E69C-9977E1AE2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340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E4D245-D351-3F03-CB78-7AE1CB72DD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2B5A09-A8D0-9995-04DD-E93466A2A3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B6D59A-66F8-7500-5F56-ACFAB1B999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43B74B-A246-852F-2C11-F85F62445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9539CC-9894-C7A2-7272-C1682BF8B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06B038-A441-AEF7-B04F-2A1604EA4B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31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9F57616-64C4-F5EC-5AAB-E39C1796C4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F8794F-C84D-23D4-59C8-A757D721F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EBA0F4-AD0A-0AC4-FA2E-903F5B9E63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741600C-438D-44E2-B5BB-FFBDFBCCA3C8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E2BFF-7873-B5C7-16EB-7BED5E0936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8EE74-8615-257C-856C-0FC1496A81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E122504-EA5E-4872-B9C8-7DAF17B0DB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276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285663" y="1867754"/>
          <a:ext cx="11687503" cy="2197632"/>
        </p:xfrm>
        <a:graphic>
          <a:graphicData uri="http://schemas.openxmlformats.org/drawingml/2006/table">
            <a:tbl>
              <a:tblPr/>
              <a:tblGrid>
                <a:gridCol w="1187669">
                  <a:extLst>
                    <a:ext uri="{9D8B030D-6E8A-4147-A177-3AD203B41FA5}">
                      <a16:colId xmlns:a16="http://schemas.microsoft.com/office/drawing/2014/main" val="1301505257"/>
                    </a:ext>
                  </a:extLst>
                </a:gridCol>
                <a:gridCol w="1040524">
                  <a:extLst>
                    <a:ext uri="{9D8B030D-6E8A-4147-A177-3AD203B41FA5}">
                      <a16:colId xmlns:a16="http://schemas.microsoft.com/office/drawing/2014/main" val="1498952803"/>
                    </a:ext>
                  </a:extLst>
                </a:gridCol>
                <a:gridCol w="872359">
                  <a:extLst>
                    <a:ext uri="{9D8B030D-6E8A-4147-A177-3AD203B41FA5}">
                      <a16:colId xmlns:a16="http://schemas.microsoft.com/office/drawing/2014/main" val="1483698973"/>
                    </a:ext>
                  </a:extLst>
                </a:gridCol>
                <a:gridCol w="1040524">
                  <a:extLst>
                    <a:ext uri="{9D8B030D-6E8A-4147-A177-3AD203B41FA5}">
                      <a16:colId xmlns:a16="http://schemas.microsoft.com/office/drawing/2014/main" val="1723963215"/>
                    </a:ext>
                  </a:extLst>
                </a:gridCol>
                <a:gridCol w="945325">
                  <a:extLst>
                    <a:ext uri="{9D8B030D-6E8A-4147-A177-3AD203B41FA5}">
                      <a16:colId xmlns:a16="http://schemas.microsoft.com/office/drawing/2014/main" val="3852637103"/>
                    </a:ext>
                  </a:extLst>
                </a:gridCol>
                <a:gridCol w="643882">
                  <a:extLst>
                    <a:ext uri="{9D8B030D-6E8A-4147-A177-3AD203B41FA5}">
                      <a16:colId xmlns:a16="http://schemas.microsoft.com/office/drawing/2014/main" val="2455096405"/>
                    </a:ext>
                  </a:extLst>
                </a:gridCol>
                <a:gridCol w="679163">
                  <a:extLst>
                    <a:ext uri="{9D8B030D-6E8A-4147-A177-3AD203B41FA5}">
                      <a16:colId xmlns:a16="http://schemas.microsoft.com/office/drawing/2014/main" val="2519692688"/>
                    </a:ext>
                  </a:extLst>
                </a:gridCol>
                <a:gridCol w="782127">
                  <a:extLst>
                    <a:ext uri="{9D8B030D-6E8A-4147-A177-3AD203B41FA5}">
                      <a16:colId xmlns:a16="http://schemas.microsoft.com/office/drawing/2014/main" val="2291691970"/>
                    </a:ext>
                  </a:extLst>
                </a:gridCol>
                <a:gridCol w="806799">
                  <a:extLst>
                    <a:ext uri="{9D8B030D-6E8A-4147-A177-3AD203B41FA5}">
                      <a16:colId xmlns:a16="http://schemas.microsoft.com/office/drawing/2014/main" val="897734760"/>
                    </a:ext>
                  </a:extLst>
                </a:gridCol>
                <a:gridCol w="3689131">
                  <a:extLst>
                    <a:ext uri="{9D8B030D-6E8A-4147-A177-3AD203B41FA5}">
                      <a16:colId xmlns:a16="http://schemas.microsoft.com/office/drawing/2014/main" val="3066430848"/>
                    </a:ext>
                  </a:extLst>
                </a:gridCol>
              </a:tblGrid>
              <a:tr h="283781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WH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urocognitiv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controls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NTC ID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/Sex/Race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</a:t>
                      </a:r>
                    </a:p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sma 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</a:t>
                      </a:r>
                      <a:r>
                        <a:rPr lang="en-US" sz="1100" b="1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F 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 viral RNA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opies/mg)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</a:t>
                      </a:r>
                      <a:r>
                        <a:rPr lang="en-US" sz="1100" b="1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isease</a:t>
                      </a:r>
                      <a:endParaRPr lang="en-US" sz="11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5184763"/>
                  </a:ext>
                </a:extLst>
              </a:tr>
              <a:tr h="185496"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 marL="6301" marR="6301" marT="6301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  <a:r>
                        <a:rPr lang="en-US" sz="1100" b="1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baseline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</a:t>
                      </a:r>
                      <a:r>
                        <a:rPr lang="en-US" sz="1100" b="0" i="0" u="none" strike="noStrike" baseline="300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baseline="30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L</a:t>
                      </a:r>
                      <a:r>
                        <a:rPr lang="en-US" sz="1100" b="1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i="0" u="none" strike="noStrike" baseline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</a:t>
                      </a:r>
                      <a:r>
                        <a:rPr lang="en-US" sz="1100" b="0" i="0" u="none" strike="noStrike" baseline="3000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en-US" sz="1100" b="0" i="0" u="none" strike="noStrike" baseline="3000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0" i="0" u="none" strike="noStrike" baseline="3000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5320185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52*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P B; HEP C; VL &gt; 750K, avascular necrosis, neuropathy-combined HIV &amp; nucleoside, fibromyalgi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7562707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06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/M/B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794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T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4702466"/>
                  </a:ext>
                </a:extLst>
              </a:tr>
              <a:tr h="212774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128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5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P CRYPTOSPORIDIUM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6989215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00048087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ASTING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5685347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194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4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PTOSPORIDIUM CRYPTOCOCCUS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3426825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00207472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/M/O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6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 mont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8486255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83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L, SQUAMOUS CELL CARCINOMA, ANAL CANCER 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4581691"/>
                  </a:ext>
                </a:extLst>
              </a:tr>
              <a:tr h="185496">
                <a:tc>
                  <a:txBody>
                    <a:bodyPr/>
                    <a:lstStyle/>
                    <a:p>
                      <a:pPr algn="ctr"/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V+ control 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09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M &amp; GM</a:t>
                      </a:r>
                    </a:p>
                  </a:txBody>
                  <a:tcPr marL="6301" marR="6301" marT="6301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/M/W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 month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sceral Kaposi's Sarcoma</a:t>
                      </a:r>
                    </a:p>
                  </a:txBody>
                  <a:tcPr marL="6301" marR="6301" marT="6301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5149449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59525" y="1613821"/>
            <a:ext cx="7386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3 Table. Characteristics of 8 HIV+ but HAND negative PWH for proteomics and RT-qPCR analysis.</a:t>
            </a:r>
          </a:p>
        </p:txBody>
      </p:sp>
      <p:sp>
        <p:nvSpPr>
          <p:cNvPr id="5" name="Rectangle 4"/>
          <p:cNvSpPr/>
          <p:nvPr/>
        </p:nvSpPr>
        <p:spPr>
          <a:xfrm>
            <a:off x="285663" y="4089050"/>
            <a:ext cx="11687504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breviations: WM, white matter; GM, gray matter; M, male; B, black; W, white; O, others. UD, under detectable. NA, not available. * donor with HCV co-infection. ^With CMV end disease.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e before death.</a:t>
            </a:r>
            <a:endParaRPr lang="en-US" sz="1100" baseline="300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8378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7</Words>
  <Application>Microsoft Office PowerPoint</Application>
  <PresentationFormat>Widescreen</PresentationFormat>
  <Paragraphs>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19:58:11Z</dcterms:created>
  <dcterms:modified xsi:type="dcterms:W3CDTF">2025-07-28T19:59:09Z</dcterms:modified>
</cp:coreProperties>
</file>